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9098B1-068C-48D3-989E-B6FA86B3B0D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DC4D1E-EDE8-460D-B1D6-A12BBFD9B6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5D77E2-4093-492C-8705-C7E155A57F1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41B496-DB51-46E2-8A3B-8335E90A52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3B378-88A5-4D45-B4D3-E433813C988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E5B0BA-FAF5-4A06-B958-F438C947E6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5837CC-3D20-44B8-82E3-23F9352433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CD60D3-1942-480D-B539-56C4E57D266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806273-F573-46D7-B3AA-7D81A6B2C2C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F56724-0501-4933-B6CF-09CB88F5E75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7B5D0-0B9D-4EC7-A208-0B2CCA46C1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C4D65E-F07D-4B21-AD03-93766F7961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B4E1228-C487-4711-8327-BE3D167E03E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563840" y="3214800"/>
          <a:ext cx="3711600" cy="28400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563840" y="3214800"/>
                    <a:ext cx="3711600" cy="2840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Text Box 3"/>
          <p:cNvSpPr/>
          <p:nvPr/>
        </p:nvSpPr>
        <p:spPr>
          <a:xfrm>
            <a:off x="5237280" y="4562640"/>
            <a:ext cx="100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45.0 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4"/>
          <p:cNvSpPr/>
          <p:nvPr/>
        </p:nvSpPr>
        <p:spPr>
          <a:xfrm>
            <a:off x="5248440" y="5011560"/>
            <a:ext cx="100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31.0 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"/>
          <p:cNvSpPr/>
          <p:nvPr/>
        </p:nvSpPr>
        <p:spPr>
          <a:xfrm>
            <a:off x="5257800" y="5672160"/>
            <a:ext cx="100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21.5 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6"/>
          <p:cNvSpPr/>
          <p:nvPr/>
        </p:nvSpPr>
        <p:spPr>
          <a:xfrm>
            <a:off x="5248440" y="4133880"/>
            <a:ext cx="100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66.2 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7"/>
          <p:cNvSpPr/>
          <p:nvPr/>
        </p:nvSpPr>
        <p:spPr>
          <a:xfrm>
            <a:off x="5246640" y="3616200"/>
            <a:ext cx="1000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97.4 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8"/>
          <p:cNvSpPr/>
          <p:nvPr/>
        </p:nvSpPr>
        <p:spPr>
          <a:xfrm>
            <a:off x="1563840" y="3214800"/>
            <a:ext cx="3711600" cy="28191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Oval 9"/>
          <p:cNvSpPr/>
          <p:nvPr/>
        </p:nvSpPr>
        <p:spPr>
          <a:xfrm>
            <a:off x="1782720" y="4903920"/>
            <a:ext cx="177840" cy="190440"/>
          </a:xfrm>
          <a:prstGeom prst="ellipse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Line 10"/>
          <p:cNvSpPr/>
          <p:nvPr/>
        </p:nvSpPr>
        <p:spPr>
          <a:xfrm flipH="1">
            <a:off x="5122800" y="374796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Line 11"/>
          <p:cNvSpPr/>
          <p:nvPr/>
        </p:nvSpPr>
        <p:spPr>
          <a:xfrm flipH="1">
            <a:off x="5122800" y="424980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Line 12"/>
          <p:cNvSpPr/>
          <p:nvPr/>
        </p:nvSpPr>
        <p:spPr>
          <a:xfrm flipH="1">
            <a:off x="5122800" y="466884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Line 13"/>
          <p:cNvSpPr/>
          <p:nvPr/>
        </p:nvSpPr>
        <p:spPr>
          <a:xfrm flipH="1">
            <a:off x="5122800" y="513252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Line 14"/>
          <p:cNvSpPr/>
          <p:nvPr/>
        </p:nvSpPr>
        <p:spPr>
          <a:xfrm flipH="1">
            <a:off x="5122800" y="5805360"/>
            <a:ext cx="152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15"/>
          <p:cNvSpPr/>
          <p:nvPr/>
        </p:nvSpPr>
        <p:spPr>
          <a:xfrm>
            <a:off x="1523880" y="2925720"/>
            <a:ext cx="3886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I 3                                                                      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Line 16"/>
          <p:cNvSpPr/>
          <p:nvPr/>
        </p:nvSpPr>
        <p:spPr>
          <a:xfrm>
            <a:off x="2038320" y="3059280"/>
            <a:ext cx="274320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9"/>
          <p:cNvSpPr/>
          <p:nvPr/>
        </p:nvSpPr>
        <p:spPr>
          <a:xfrm>
            <a:off x="914400" y="6781680"/>
            <a:ext cx="48769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dditional file 1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 2-D gel analysis of poplar phloem exudate proteins (50µg). The 31 kDa TLP that was sequenced by LC-MS/MS is circled.</a:t>
            </a:r>
            <a:r>
              <a:rPr b="0" lang="en-AU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4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17T22:42:32Z</dcterms:created>
  <dc:creator>Nicole Dafoe</dc:creator>
  <dc:description/>
  <dc:language>en-US</dc:language>
  <cp:lastModifiedBy>peterconstabel Constabel</cp:lastModifiedBy>
  <dcterms:modified xsi:type="dcterms:W3CDTF">2010-08-23T17:42:41Z</dcterms:modified>
  <cp:revision>4</cp:revision>
  <dc:subject/>
  <dc:title>Slide 1</dc:title>
</cp:coreProperties>
</file>